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rypotou, Aimilia" userId="3383a474-3fc2-4c30-947f-c16ae8f712c0" providerId="ADAL" clId="{4D067FEE-28CF-034E-A492-6849B1F93B27}"/>
    <pc:docChg chg="delSld">
      <pc:chgData name="Krypotou, Aimilia" userId="3383a474-3fc2-4c30-947f-c16ae8f712c0" providerId="ADAL" clId="{4D067FEE-28CF-034E-A492-6849B1F93B27}" dt="2025-12-29T17:54:53.031" v="6" actId="2696"/>
      <pc:docMkLst>
        <pc:docMk/>
      </pc:docMkLst>
      <pc:sldChg chg="del">
        <pc:chgData name="Krypotou, Aimilia" userId="3383a474-3fc2-4c30-947f-c16ae8f712c0" providerId="ADAL" clId="{4D067FEE-28CF-034E-A492-6849B1F93B27}" dt="2025-12-29T17:54:50.595" v="0" actId="2696"/>
        <pc:sldMkLst>
          <pc:docMk/>
          <pc:sldMk cId="1939867441" sldId="259"/>
        </pc:sldMkLst>
      </pc:sldChg>
      <pc:sldChg chg="del">
        <pc:chgData name="Krypotou, Aimilia" userId="3383a474-3fc2-4c30-947f-c16ae8f712c0" providerId="ADAL" clId="{4D067FEE-28CF-034E-A492-6849B1F93B27}" dt="2025-12-29T17:54:51.174" v="1" actId="2696"/>
        <pc:sldMkLst>
          <pc:docMk/>
          <pc:sldMk cId="1686765377" sldId="260"/>
        </pc:sldMkLst>
      </pc:sldChg>
      <pc:sldChg chg="del">
        <pc:chgData name="Krypotou, Aimilia" userId="3383a474-3fc2-4c30-947f-c16ae8f712c0" providerId="ADAL" clId="{4D067FEE-28CF-034E-A492-6849B1F93B27}" dt="2025-12-29T17:54:51.501" v="2" actId="2696"/>
        <pc:sldMkLst>
          <pc:docMk/>
          <pc:sldMk cId="2404163418" sldId="261"/>
        </pc:sldMkLst>
      </pc:sldChg>
      <pc:sldChg chg="del">
        <pc:chgData name="Krypotou, Aimilia" userId="3383a474-3fc2-4c30-947f-c16ae8f712c0" providerId="ADAL" clId="{4D067FEE-28CF-034E-A492-6849B1F93B27}" dt="2025-12-29T17:54:51.878" v="3" actId="2696"/>
        <pc:sldMkLst>
          <pc:docMk/>
          <pc:sldMk cId="3624173451" sldId="262"/>
        </pc:sldMkLst>
      </pc:sldChg>
      <pc:sldChg chg="del">
        <pc:chgData name="Krypotou, Aimilia" userId="3383a474-3fc2-4c30-947f-c16ae8f712c0" providerId="ADAL" clId="{4D067FEE-28CF-034E-A492-6849B1F93B27}" dt="2025-12-29T17:54:52.202" v="4" actId="2696"/>
        <pc:sldMkLst>
          <pc:docMk/>
          <pc:sldMk cId="2855954256" sldId="263"/>
        </pc:sldMkLst>
      </pc:sldChg>
      <pc:sldChg chg="del">
        <pc:chgData name="Krypotou, Aimilia" userId="3383a474-3fc2-4c30-947f-c16ae8f712c0" providerId="ADAL" clId="{4D067FEE-28CF-034E-A492-6849B1F93B27}" dt="2025-12-29T17:54:52.447" v="5" actId="2696"/>
        <pc:sldMkLst>
          <pc:docMk/>
          <pc:sldMk cId="953867029" sldId="264"/>
        </pc:sldMkLst>
      </pc:sldChg>
      <pc:sldChg chg="del">
        <pc:chgData name="Krypotou, Aimilia" userId="3383a474-3fc2-4c30-947f-c16ae8f712c0" providerId="ADAL" clId="{4D067FEE-28CF-034E-A492-6849B1F93B27}" dt="2025-12-29T17:54:53.031" v="6" actId="2696"/>
        <pc:sldMkLst>
          <pc:docMk/>
          <pc:sldMk cId="3450662349" sldId="26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39B4D-ECF8-792D-1E8E-DF17ECEED5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D0879E-100B-DECF-ADC4-DD144A9F53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7B0E5-B386-FA8C-5E4D-D1C5BF27B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5C8D2-18BF-6595-722E-6999D7A36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2F598-7557-0892-70CE-037BE38C9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16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9735B9-A882-17DE-166E-1FFC527ED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95B352-0CB7-C535-D0A0-BC54E1A56D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903C03-7066-EBE1-1117-4E84E2D84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1619AD-FEE7-1E7C-46DE-0FE11435E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900E21-AE59-584E-7CB2-61FC62D50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694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B058CB-508B-7C04-5F5D-165C615F30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4EE964-EC5F-1496-5CE4-A672AE858A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09E7AE-59BD-B6A7-2DE5-B720CDD64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45B330-05E5-99FB-0CA9-A7ABDE40F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9482F0-523B-58BB-D7B0-F9044F67B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862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31038-98AD-FC0F-B704-751CF229D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AF3291-B390-0786-33A3-CFDB085817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44927B-6AC0-2DEB-AE94-7CA7419E7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8DE34D-7DD7-54E8-A497-8DDE42296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54AF8E-1C5E-75CC-323B-31B1E01C1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FFB8A-E374-BC4D-7A8B-7300C78D5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95A331-2912-E524-05E2-0F6E4A65B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92109-A65E-FBCC-7828-B5B8B5E09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D297F6-7F01-7243-AB92-3F1929F38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98FB16-81D5-5FE7-DFC5-DCCD5D8E5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89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F1EEE-0322-6F4E-76BA-966DD2197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046413-ABAD-9B9F-6E90-2136C73EF3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CCB1C5-26ED-762B-589D-0A29D69A52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9FA54-F6D7-96A7-5C81-5AAA11200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6AB86B-673B-D28A-5501-AD67EFB74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6AF430-F379-5012-0955-9A6C42F54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379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A211F-1FAA-0E9E-4E93-9D596DC6F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3BA49A-7628-A281-B85B-499DADD6D1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FA5670-B4A0-74D4-66B0-88CF9F2723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F9B0AF-10FC-1265-A51C-9F68991AE1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4707EC-24D8-84D4-C76E-AEE7DF571C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FF2908-DCD4-2604-0388-8E7AFF8D1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C54A6C-1F79-4262-6103-698FBAC93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57B865-B32C-25E7-8180-3E3912AB3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750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06E56-0866-6FAB-15C3-FC50CEED4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36E4A-366D-B46F-E3A6-32ADFC459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4B04D4-8C00-3F8A-1750-0BEFBEC4D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2AD13E-4F97-AA98-E7E0-808211240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71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E0B539-3FD6-D832-DB3E-0B793AEA4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28AD91-3200-ECA6-A1B1-95D01552D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0CFF6B-067B-5DC6-F9CB-3B837B741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983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1A002-F5AB-6B48-2E07-B610C66BF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61A05-5520-38A9-5BFC-CE245ECBB3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50FDCE-7FF9-762F-2B0E-2D6A830C3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5CCA21-BC9B-7F6B-8196-F4501BB73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E904E3-882B-C825-D389-1037BC0F3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BEC86-FB13-F957-46C1-ECD34AD5B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885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EC99E-E26C-F422-1CE4-B16CF38EC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4728B2-D16D-9B9D-32F6-34ABAA451C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157CE5-0FDC-489A-8472-CC0C9411E1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B9FF73-8F4D-C276-0B53-1F8DFFA26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F63DC4-639C-A347-5BE9-41CEEA2E0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0B7E76-6F50-1272-E45E-779FFC750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89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CB923C-6F2D-B027-721B-FF049C83D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6A7E17-8CE2-2D48-E320-11053EAD0A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D5C985-63C8-D967-1940-EFFB825508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07093-3A49-1398-E7D3-63464BED73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812A23-3A34-9736-5C1E-11D8A5FB94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7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C9349E0-691E-A020-C47E-605CBF33F186}"/>
              </a:ext>
            </a:extLst>
          </p:cNvPr>
          <p:cNvSpPr txBox="1"/>
          <p:nvPr/>
        </p:nvSpPr>
        <p:spPr>
          <a:xfrm>
            <a:off x="625033" y="358815"/>
            <a:ext cx="2973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C </a:t>
            </a:r>
            <a:r>
              <a:rPr lang="en-US" dirty="0" err="1"/>
              <a:t>pppGpp</a:t>
            </a:r>
            <a:r>
              <a:rPr lang="en-US" dirty="0"/>
              <a:t> vs </a:t>
            </a:r>
            <a:r>
              <a:rPr lang="en-US" dirty="0" err="1"/>
              <a:t>ppGpp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3D0397F-C0C6-DEED-50E3-0EB47AB433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53926" y="369332"/>
            <a:ext cx="2172275" cy="336514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D36E84B-85D3-2DC0-5F40-43DCEDACC7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7763" y="132231"/>
            <a:ext cx="2097197" cy="3602243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3952D18-3797-EC4A-E136-CB0D281CD717}"/>
              </a:ext>
            </a:extLst>
          </p:cNvPr>
          <p:cNvCxnSpPr/>
          <p:nvPr/>
        </p:nvCxnSpPr>
        <p:spPr>
          <a:xfrm>
            <a:off x="6413162" y="463521"/>
            <a:ext cx="150920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92A8740-C3AA-CE83-BE79-1F28AFF9FCEE}"/>
              </a:ext>
            </a:extLst>
          </p:cNvPr>
          <p:cNvCxnSpPr>
            <a:cxnSpLocks/>
          </p:cNvCxnSpPr>
          <p:nvPr/>
        </p:nvCxnSpPr>
        <p:spPr>
          <a:xfrm>
            <a:off x="9592847" y="358469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C5C3F07-A4C3-111F-3487-D2BCAF16BE44}"/>
              </a:ext>
            </a:extLst>
          </p:cNvPr>
          <p:cNvSpPr txBox="1"/>
          <p:nvPr/>
        </p:nvSpPr>
        <p:spPr>
          <a:xfrm>
            <a:off x="6249884" y="94189"/>
            <a:ext cx="1835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5nM *pppGp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A228D1-730F-847B-BAC8-7D97B140889D}"/>
              </a:ext>
            </a:extLst>
          </p:cNvPr>
          <p:cNvSpPr txBox="1"/>
          <p:nvPr/>
        </p:nvSpPr>
        <p:spPr>
          <a:xfrm>
            <a:off x="9595252" y="0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DF51AF8-6376-4CA9-4F10-22DC6A57FA50}"/>
              </a:ext>
            </a:extLst>
          </p:cNvPr>
          <p:cNvSpPr txBox="1"/>
          <p:nvPr/>
        </p:nvSpPr>
        <p:spPr>
          <a:xfrm>
            <a:off x="4655384" y="570052"/>
            <a:ext cx="1417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5A8B7E7-CC34-DBD8-1938-923F6C9F9345}"/>
              </a:ext>
            </a:extLst>
          </p:cNvPr>
          <p:cNvSpPr txBox="1"/>
          <p:nvPr/>
        </p:nvSpPr>
        <p:spPr>
          <a:xfrm>
            <a:off x="4517526" y="1049627"/>
            <a:ext cx="1555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7D00162-5642-BD7B-C476-0942B74E049A}"/>
              </a:ext>
            </a:extLst>
          </p:cNvPr>
          <p:cNvSpPr txBox="1"/>
          <p:nvPr/>
        </p:nvSpPr>
        <p:spPr>
          <a:xfrm>
            <a:off x="4483863" y="1547007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0016A6-B67C-5B53-D345-6755E1F626C9}"/>
              </a:ext>
            </a:extLst>
          </p:cNvPr>
          <p:cNvSpPr txBox="1"/>
          <p:nvPr/>
        </p:nvSpPr>
        <p:spPr>
          <a:xfrm>
            <a:off x="4386079" y="2015796"/>
            <a:ext cx="1686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C96B36-E81F-3773-D40B-A941247E7F72}"/>
              </a:ext>
            </a:extLst>
          </p:cNvPr>
          <p:cNvSpPr txBox="1"/>
          <p:nvPr/>
        </p:nvSpPr>
        <p:spPr>
          <a:xfrm>
            <a:off x="4485091" y="2499341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2AE3D08-0733-697A-5A8A-9FEA91B8361C}"/>
              </a:ext>
            </a:extLst>
          </p:cNvPr>
          <p:cNvSpPr txBox="1"/>
          <p:nvPr/>
        </p:nvSpPr>
        <p:spPr>
          <a:xfrm>
            <a:off x="3682467" y="2896483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529DD0B-B166-6292-8965-E1BE204E533A}"/>
              </a:ext>
            </a:extLst>
          </p:cNvPr>
          <p:cNvSpPr txBox="1"/>
          <p:nvPr/>
        </p:nvSpPr>
        <p:spPr>
          <a:xfrm>
            <a:off x="4386805" y="4595149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1</a:t>
            </a:r>
          </a:p>
        </p:txBody>
      </p:sp>
    </p:spTree>
    <p:extLst>
      <p:ext uri="{BB962C8B-B14F-4D97-AF65-F5344CB8AC3E}">
        <p14:creationId xmlns:p14="http://schemas.microsoft.com/office/powerpoint/2010/main" val="3552300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E69A17F-2208-4364-F1CD-1FD899933C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6161" y="1738076"/>
            <a:ext cx="5699678" cy="4014654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CE2DFDB-1027-865F-4DAA-AF520F369A2B}"/>
              </a:ext>
            </a:extLst>
          </p:cNvPr>
          <p:cNvCxnSpPr/>
          <p:nvPr/>
        </p:nvCxnSpPr>
        <p:spPr>
          <a:xfrm>
            <a:off x="3693111" y="1926454"/>
            <a:ext cx="150920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165EB9F-7FC5-44CC-0861-DAD37B3E1CB8}"/>
              </a:ext>
            </a:extLst>
          </p:cNvPr>
          <p:cNvCxnSpPr>
            <a:cxnSpLocks/>
          </p:cNvCxnSpPr>
          <p:nvPr/>
        </p:nvCxnSpPr>
        <p:spPr>
          <a:xfrm>
            <a:off x="6872796" y="1821402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6771DD5B-FCEF-7675-4FB2-6BF87BFB9095}"/>
              </a:ext>
            </a:extLst>
          </p:cNvPr>
          <p:cNvSpPr txBox="1"/>
          <p:nvPr/>
        </p:nvSpPr>
        <p:spPr>
          <a:xfrm>
            <a:off x="3529833" y="1557122"/>
            <a:ext cx="1835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5nM *pppGp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4CE2A50-5E80-CC3E-7EFC-FB890563F253}"/>
              </a:ext>
            </a:extLst>
          </p:cNvPr>
          <p:cNvSpPr txBox="1"/>
          <p:nvPr/>
        </p:nvSpPr>
        <p:spPr>
          <a:xfrm>
            <a:off x="6875201" y="1462933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BC95D3-8F7E-3FFF-9FB1-A81A2D97AFA8}"/>
              </a:ext>
            </a:extLst>
          </p:cNvPr>
          <p:cNvSpPr txBox="1"/>
          <p:nvPr/>
        </p:nvSpPr>
        <p:spPr>
          <a:xfrm>
            <a:off x="1935333" y="2032985"/>
            <a:ext cx="1417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6EF3DA-3C7B-F25A-1AC6-9830302A36F0}"/>
              </a:ext>
            </a:extLst>
          </p:cNvPr>
          <p:cNvSpPr txBox="1"/>
          <p:nvPr/>
        </p:nvSpPr>
        <p:spPr>
          <a:xfrm>
            <a:off x="1797475" y="2512560"/>
            <a:ext cx="1555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80963D-99B1-AD54-ED8B-357BFF091446}"/>
              </a:ext>
            </a:extLst>
          </p:cNvPr>
          <p:cNvSpPr txBox="1"/>
          <p:nvPr/>
        </p:nvSpPr>
        <p:spPr>
          <a:xfrm>
            <a:off x="1763812" y="300994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F4265B-4C1E-2D5D-5036-618FFEC9493F}"/>
              </a:ext>
            </a:extLst>
          </p:cNvPr>
          <p:cNvSpPr txBox="1"/>
          <p:nvPr/>
        </p:nvSpPr>
        <p:spPr>
          <a:xfrm>
            <a:off x="1666028" y="3478729"/>
            <a:ext cx="1686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5F49D7-2836-B860-5EB0-8BC03CB1F6A3}"/>
              </a:ext>
            </a:extLst>
          </p:cNvPr>
          <p:cNvSpPr txBox="1"/>
          <p:nvPr/>
        </p:nvSpPr>
        <p:spPr>
          <a:xfrm>
            <a:off x="1765040" y="3962274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A44425-C417-AC6C-362B-E1D4B8321659}"/>
              </a:ext>
            </a:extLst>
          </p:cNvPr>
          <p:cNvSpPr txBox="1"/>
          <p:nvPr/>
        </p:nvSpPr>
        <p:spPr>
          <a:xfrm>
            <a:off x="696532" y="4459654"/>
            <a:ext cx="2656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00nM </a:t>
            </a:r>
            <a:r>
              <a:rPr lang="en-US" dirty="0" err="1"/>
              <a:t>HprT</a:t>
            </a:r>
            <a:r>
              <a:rPr lang="en-US" dirty="0"/>
              <a:t> + MgCl</a:t>
            </a:r>
            <a:r>
              <a:rPr lang="en-US" baseline="-25000" dirty="0"/>
              <a:t>2</a:t>
            </a:r>
            <a:r>
              <a:rPr lang="en-US" dirty="0"/>
              <a:t> +c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33C816-07FB-A1E9-902F-B4961948B4B7}"/>
              </a:ext>
            </a:extLst>
          </p:cNvPr>
          <p:cNvSpPr txBox="1"/>
          <p:nvPr/>
        </p:nvSpPr>
        <p:spPr>
          <a:xfrm>
            <a:off x="515018" y="4878542"/>
            <a:ext cx="2850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Rho binding buffer only -c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5CC9B4-0580-F9DF-C538-815223D13EA2}"/>
              </a:ext>
            </a:extLst>
          </p:cNvPr>
          <p:cNvSpPr txBox="1"/>
          <p:nvPr/>
        </p:nvSpPr>
        <p:spPr>
          <a:xfrm>
            <a:off x="625033" y="358815"/>
            <a:ext cx="2973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C </a:t>
            </a:r>
            <a:r>
              <a:rPr lang="en-US" dirty="0" err="1"/>
              <a:t>pppGpp</a:t>
            </a:r>
            <a:r>
              <a:rPr lang="en-US" dirty="0"/>
              <a:t> vs </a:t>
            </a:r>
            <a:r>
              <a:rPr lang="en-US" dirty="0" err="1"/>
              <a:t>ppGpp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BE1B0C-A342-4558-8F82-B713541C87B2}"/>
              </a:ext>
            </a:extLst>
          </p:cNvPr>
          <p:cNvSpPr txBox="1"/>
          <p:nvPr/>
        </p:nvSpPr>
        <p:spPr>
          <a:xfrm>
            <a:off x="5202315" y="679114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2</a:t>
            </a:r>
          </a:p>
        </p:txBody>
      </p:sp>
    </p:spTree>
    <p:extLst>
      <p:ext uri="{BB962C8B-B14F-4D97-AF65-F5344CB8AC3E}">
        <p14:creationId xmlns:p14="http://schemas.microsoft.com/office/powerpoint/2010/main" val="2809017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2C1A78F-2E8F-4FB8-BFD0-EB77C0B0AF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97385" y="1462933"/>
            <a:ext cx="1986580" cy="341224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FFC24D6-34CE-5ECB-A4E2-015F3DB847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9833" y="1647601"/>
            <a:ext cx="2050502" cy="3152796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B808A05B-AC75-5D35-B2A9-D2D409E9213E}"/>
              </a:ext>
            </a:extLst>
          </p:cNvPr>
          <p:cNvCxnSpPr/>
          <p:nvPr/>
        </p:nvCxnSpPr>
        <p:spPr>
          <a:xfrm>
            <a:off x="3693111" y="1926454"/>
            <a:ext cx="150920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A031075-CAEF-4254-7283-19CD875489B4}"/>
              </a:ext>
            </a:extLst>
          </p:cNvPr>
          <p:cNvCxnSpPr>
            <a:cxnSpLocks/>
          </p:cNvCxnSpPr>
          <p:nvPr/>
        </p:nvCxnSpPr>
        <p:spPr>
          <a:xfrm>
            <a:off x="6872796" y="1821402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62A164B4-8140-E5B6-F8AD-33D262FDF975}"/>
              </a:ext>
            </a:extLst>
          </p:cNvPr>
          <p:cNvSpPr txBox="1"/>
          <p:nvPr/>
        </p:nvSpPr>
        <p:spPr>
          <a:xfrm>
            <a:off x="3529833" y="1557122"/>
            <a:ext cx="18357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5nM *pppGp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C06960-0F55-473C-CAC7-3B2A2E2E4DAF}"/>
              </a:ext>
            </a:extLst>
          </p:cNvPr>
          <p:cNvSpPr txBox="1"/>
          <p:nvPr/>
        </p:nvSpPr>
        <p:spPr>
          <a:xfrm>
            <a:off x="6875201" y="1462933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B6EB0A-3BFA-37EE-FEE5-5C02EBD583D0}"/>
              </a:ext>
            </a:extLst>
          </p:cNvPr>
          <p:cNvSpPr txBox="1"/>
          <p:nvPr/>
        </p:nvSpPr>
        <p:spPr>
          <a:xfrm>
            <a:off x="1935333" y="2032985"/>
            <a:ext cx="1417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CB45AE-F4CE-0EC6-31D5-51B795577A62}"/>
              </a:ext>
            </a:extLst>
          </p:cNvPr>
          <p:cNvSpPr txBox="1"/>
          <p:nvPr/>
        </p:nvSpPr>
        <p:spPr>
          <a:xfrm>
            <a:off x="1797475" y="2512560"/>
            <a:ext cx="1555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IDR Rh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F3E7AC3-13F5-75C5-F735-7D0D7C01E1F2}"/>
              </a:ext>
            </a:extLst>
          </p:cNvPr>
          <p:cNvSpPr txBox="1"/>
          <p:nvPr/>
        </p:nvSpPr>
        <p:spPr>
          <a:xfrm>
            <a:off x="1763812" y="300994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CDA50B3-7655-2D3E-66BA-1D1786234395}"/>
              </a:ext>
            </a:extLst>
          </p:cNvPr>
          <p:cNvSpPr txBox="1"/>
          <p:nvPr/>
        </p:nvSpPr>
        <p:spPr>
          <a:xfrm>
            <a:off x="1666028" y="3478729"/>
            <a:ext cx="1686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5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rich</a:t>
            </a:r>
            <a:r>
              <a:rPr lang="en-US" dirty="0"/>
              <a:t> Rh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0478F0-A62C-67A6-C2E6-2758102FC92B}"/>
              </a:ext>
            </a:extLst>
          </p:cNvPr>
          <p:cNvSpPr txBox="1"/>
          <p:nvPr/>
        </p:nvSpPr>
        <p:spPr>
          <a:xfrm>
            <a:off x="1765040" y="3962274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.5</a:t>
            </a:r>
            <a:r>
              <a:rPr lang="el-GR" dirty="0"/>
              <a:t>μ</a:t>
            </a:r>
            <a:r>
              <a:rPr lang="en-US" dirty="0"/>
              <a:t>M IDR Rh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D6DABEC-322A-6A10-19DF-3F3E357F3FAF}"/>
              </a:ext>
            </a:extLst>
          </p:cNvPr>
          <p:cNvSpPr txBox="1"/>
          <p:nvPr/>
        </p:nvSpPr>
        <p:spPr>
          <a:xfrm>
            <a:off x="515018" y="4431063"/>
            <a:ext cx="2850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Rho binding buffer only -c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E66C94-5BB5-CBC7-5C47-2276CB03A661}"/>
              </a:ext>
            </a:extLst>
          </p:cNvPr>
          <p:cNvSpPr txBox="1"/>
          <p:nvPr/>
        </p:nvSpPr>
        <p:spPr>
          <a:xfrm>
            <a:off x="5202315" y="679114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B757D6-C6C0-9EBB-141B-375246060EEE}"/>
              </a:ext>
            </a:extLst>
          </p:cNvPr>
          <p:cNvSpPr txBox="1"/>
          <p:nvPr/>
        </p:nvSpPr>
        <p:spPr>
          <a:xfrm>
            <a:off x="625033" y="358815"/>
            <a:ext cx="2973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C </a:t>
            </a:r>
            <a:r>
              <a:rPr lang="en-US" dirty="0" err="1"/>
              <a:t>pppGpp</a:t>
            </a:r>
            <a:r>
              <a:rPr lang="en-US" dirty="0"/>
              <a:t> vs </a:t>
            </a:r>
            <a:r>
              <a:rPr lang="en-US" dirty="0" err="1"/>
              <a:t>ppGp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2642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dd8cbebb-2139-4df8-b411-4e3e87abeb5c}" enabled="0" method="" siteId="{dd8cbebb-2139-4df8-b411-4e3e87abeb5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146</Words>
  <Application>Microsoft Macintosh PowerPoint</Application>
  <PresentationFormat>Widescreen</PresentationFormat>
  <Paragraphs>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ypotou, Aimilia</dc:creator>
  <cp:lastModifiedBy>Krypotou, Aimilia</cp:lastModifiedBy>
  <cp:revision>1</cp:revision>
  <dcterms:created xsi:type="dcterms:W3CDTF">2025-12-06T18:43:48Z</dcterms:created>
  <dcterms:modified xsi:type="dcterms:W3CDTF">2025-12-29T17:54:55Z</dcterms:modified>
</cp:coreProperties>
</file>